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6" d="100"/>
          <a:sy n="116" d="100"/>
        </p:scale>
        <p:origin x="336"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E00876B-FDC9-3F74-0749-9F91CAA128CF}"/>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A27570F0-39AA-2FF5-25EF-D700675DE14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57CB4343-85AC-FF26-5E6A-1738BCF0BEE8}"/>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FB1D568E-8E92-2D4B-1C99-C46596542459}"/>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6E8F0555-64C7-ABBE-0DBC-DD616786070F}"/>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19437790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C0032B8-0B61-DC77-B546-F129BD23445E}"/>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C663A2D3-1E85-059B-D21B-B39F7AC5FC68}"/>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5E5B62E8-6A35-3A89-EA6F-C7269A1DAD19}"/>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D3BEC10D-4F33-27C8-CFF1-E9E5A879D03F}"/>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87E4705-73D8-9D79-2E00-92D8673354CD}"/>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33150293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682C9AFD-9EB1-7298-ADD8-18D3CF7BBB71}"/>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EA62321-C714-376F-2183-AAFD7FABE784}"/>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A76856A-1AC5-B7AA-4FFC-65F4A71900D1}"/>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47F85F07-C92F-BE57-4CD8-5AA542E14402}"/>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A9F3DA6F-622C-B70F-064C-444ADED63275}"/>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25679804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0B7F86B-2828-1350-7A2B-A576AEF8E8A3}"/>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1E0652C6-BFD3-64C1-C973-257B8EE24032}"/>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03CEFF9D-6158-A304-8BD5-9AF79C715314}"/>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4E9CF140-EA87-C9CC-847A-E070738B383F}"/>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82BE179F-968A-B9BF-E89D-F0CB1594A71C}"/>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24019947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9B405FE-CE0C-904E-2B76-A2B57706EEFF}"/>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F23AB93E-1F16-E3D0-7150-DAFF70A41A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E1FE9FC9-C02A-A45A-7457-6841D9ED18FE}"/>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54EE9F63-E151-DA8D-F487-8B5736F28D5C}"/>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F3340D8-8318-4799-9F57-5A7CB62B5E92}"/>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34222816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37623B5-0EA4-8448-953C-97150D8CE4F0}"/>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B55389DC-3269-CE0E-7900-A71BA2D21706}"/>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0DC929FD-2424-01C5-532F-D7D7170C1849}"/>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86C664E5-5CE6-1FED-ED41-CEC07176EE19}"/>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6" name="Espace réservé du pied de page 5">
            <a:extLst>
              <a:ext uri="{FF2B5EF4-FFF2-40B4-BE49-F238E27FC236}">
                <a16:creationId xmlns:a16="http://schemas.microsoft.com/office/drawing/2014/main" id="{38FA400C-6CC5-2FA4-2C98-DDFDD05E65DF}"/>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FF7EEBD9-7296-690C-7CCF-B78B0C3C99FC}"/>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22011974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F707FB1-4441-E8EF-39CF-EC29647C63DB}"/>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E70A9496-6851-71DF-6EAA-A02504FE5A0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1BF18B1B-62E8-2434-632E-62382C18DD09}"/>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031E1995-9799-AE01-944E-4384CD96AB2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CBE9A673-8AD3-33EC-5EF8-1D6D98D2A02E}"/>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27DC88FD-45BF-AE7F-AD80-88828ACBF29F}"/>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8" name="Espace réservé du pied de page 7">
            <a:extLst>
              <a:ext uri="{FF2B5EF4-FFF2-40B4-BE49-F238E27FC236}">
                <a16:creationId xmlns:a16="http://schemas.microsoft.com/office/drawing/2014/main" id="{3A69EF85-0BA3-28E2-2E6E-498BA36DF74A}"/>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3FE9CE32-21D9-8401-07FA-F31C80F39A44}"/>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35603363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FDE5858-22D9-1954-B65C-1C53631924BC}"/>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BE7AF656-31A5-8CE0-475C-CBAD548A1009}"/>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4" name="Espace réservé du pied de page 3">
            <a:extLst>
              <a:ext uri="{FF2B5EF4-FFF2-40B4-BE49-F238E27FC236}">
                <a16:creationId xmlns:a16="http://schemas.microsoft.com/office/drawing/2014/main" id="{E8DA7B9F-8657-2274-EE38-AC33AA68C808}"/>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1720E58B-7C3C-AD63-85CB-D9CD6F6A31A1}"/>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32161102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47A4D5B2-22AD-F2EF-84DD-EFB16CE03A4E}"/>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3" name="Espace réservé du pied de page 2">
            <a:extLst>
              <a:ext uri="{FF2B5EF4-FFF2-40B4-BE49-F238E27FC236}">
                <a16:creationId xmlns:a16="http://schemas.microsoft.com/office/drawing/2014/main" id="{D3F94E27-CF45-7520-D1FE-960D8ADCE0A7}"/>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D13FC0C4-2FE7-D84D-EC58-145569088FA0}"/>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20241944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A047332-BEE2-4B74-A30D-6F5A27261CCD}"/>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D2CCBB48-38FB-1B2C-BEFB-0D406E9BCE7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99436053-FC8D-29AC-420C-DA065F969A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D399FE5B-73D9-8145-8474-DB3721FB3D86}"/>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6" name="Espace réservé du pied de page 5">
            <a:extLst>
              <a:ext uri="{FF2B5EF4-FFF2-40B4-BE49-F238E27FC236}">
                <a16:creationId xmlns:a16="http://schemas.microsoft.com/office/drawing/2014/main" id="{EEC3FDBE-D697-1BCF-571F-2D4A34A02CE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323BAF71-E444-D082-DF1E-A4578B54DEA2}"/>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41903316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6890C28-E72B-1F94-7885-E98FC0C8C786}"/>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DEC32257-5B23-E8D6-A2DD-F72B10A1D7F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5984115A-F8E6-3523-D219-D4C96E3AB7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681C7A92-AC9F-DCF9-FF88-7210B7317B96}"/>
              </a:ext>
            </a:extLst>
          </p:cNvPr>
          <p:cNvSpPr>
            <a:spLocks noGrp="1"/>
          </p:cNvSpPr>
          <p:nvPr>
            <p:ph type="dt" sz="half" idx="10"/>
          </p:nvPr>
        </p:nvSpPr>
        <p:spPr/>
        <p:txBody>
          <a:bodyPr/>
          <a:lstStyle/>
          <a:p>
            <a:fld id="{E309115A-B031-44E0-AD24-0ECF29A8D6EE}" type="datetimeFigureOut">
              <a:rPr lang="fr-FR" smtClean="0"/>
              <a:t>01/12/2022</a:t>
            </a:fld>
            <a:endParaRPr lang="fr-FR"/>
          </a:p>
        </p:txBody>
      </p:sp>
      <p:sp>
        <p:nvSpPr>
          <p:cNvPr id="6" name="Espace réservé du pied de page 5">
            <a:extLst>
              <a:ext uri="{FF2B5EF4-FFF2-40B4-BE49-F238E27FC236}">
                <a16:creationId xmlns:a16="http://schemas.microsoft.com/office/drawing/2014/main" id="{68EA8030-EFCE-489E-E936-7AF164D27336}"/>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9162066-5562-50B2-60BB-1A04F98C6361}"/>
              </a:ext>
            </a:extLst>
          </p:cNvPr>
          <p:cNvSpPr>
            <a:spLocks noGrp="1"/>
          </p:cNvSpPr>
          <p:nvPr>
            <p:ph type="sldNum" sz="quarter" idx="12"/>
          </p:nvPr>
        </p:nvSpPr>
        <p:spPr/>
        <p:txBody>
          <a:bodyPr/>
          <a:lstStyle/>
          <a:p>
            <a:fld id="{FB59805D-8457-4E60-9152-76573FD89A01}" type="slidenum">
              <a:rPr lang="fr-FR" smtClean="0"/>
              <a:t>‹N°›</a:t>
            </a:fld>
            <a:endParaRPr lang="fr-FR"/>
          </a:p>
        </p:txBody>
      </p:sp>
    </p:spTree>
    <p:extLst>
      <p:ext uri="{BB962C8B-B14F-4D97-AF65-F5344CB8AC3E}">
        <p14:creationId xmlns:p14="http://schemas.microsoft.com/office/powerpoint/2010/main" val="19806669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A38058CF-2770-592E-73A1-45EF7F669B5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4364987B-8726-F36F-26F7-D03B4B1123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791FE697-C3D6-3C77-5DD6-2601A22DD6F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09115A-B031-44E0-AD24-0ECF29A8D6EE}" type="datetimeFigureOut">
              <a:rPr lang="fr-FR" smtClean="0"/>
              <a:t>01/12/2022</a:t>
            </a:fld>
            <a:endParaRPr lang="fr-FR"/>
          </a:p>
        </p:txBody>
      </p:sp>
      <p:sp>
        <p:nvSpPr>
          <p:cNvPr id="5" name="Espace réservé du pied de page 4">
            <a:extLst>
              <a:ext uri="{FF2B5EF4-FFF2-40B4-BE49-F238E27FC236}">
                <a16:creationId xmlns:a16="http://schemas.microsoft.com/office/drawing/2014/main" id="{8F694277-FDD2-D7C1-CF83-16F73E1961C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A9A1687B-5067-C692-E89C-509CA7AD51E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B59805D-8457-4E60-9152-76573FD89A01}" type="slidenum">
              <a:rPr lang="fr-FR" smtClean="0"/>
              <a:t>‹N°›</a:t>
            </a:fld>
            <a:endParaRPr lang="fr-FR"/>
          </a:p>
        </p:txBody>
      </p:sp>
    </p:spTree>
    <p:extLst>
      <p:ext uri="{BB962C8B-B14F-4D97-AF65-F5344CB8AC3E}">
        <p14:creationId xmlns:p14="http://schemas.microsoft.com/office/powerpoint/2010/main" val="23935945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9B16792C-4FB1-3F83-A5B4-843BC680069B}"/>
              </a:ext>
            </a:extLst>
          </p:cNvPr>
          <p:cNvPicPr>
            <a:picLocks noChangeAspect="1"/>
          </p:cNvPicPr>
          <p:nvPr/>
        </p:nvPicPr>
        <p:blipFill>
          <a:blip r:embed="rId2"/>
          <a:stretch>
            <a:fillRect/>
          </a:stretch>
        </p:blipFill>
        <p:spPr>
          <a:xfrm>
            <a:off x="1556439" y="967397"/>
            <a:ext cx="10635561" cy="4264027"/>
          </a:xfrm>
          <a:prstGeom prst="rect">
            <a:avLst/>
          </a:prstGeom>
        </p:spPr>
      </p:pic>
      <p:sp>
        <p:nvSpPr>
          <p:cNvPr id="6" name="Parenthèse ouvrante 5">
            <a:extLst>
              <a:ext uri="{FF2B5EF4-FFF2-40B4-BE49-F238E27FC236}">
                <a16:creationId xmlns:a16="http://schemas.microsoft.com/office/drawing/2014/main" id="{BB8ABA96-6A31-02E5-4BD7-9A279A0AA6C3}"/>
              </a:ext>
            </a:extLst>
          </p:cNvPr>
          <p:cNvSpPr/>
          <p:nvPr/>
        </p:nvSpPr>
        <p:spPr>
          <a:xfrm>
            <a:off x="1477108" y="1784838"/>
            <a:ext cx="79331" cy="545124"/>
          </a:xfrm>
          <a:prstGeom prst="leftBracket">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7" name="Parenthèse ouvrante 6">
            <a:extLst>
              <a:ext uri="{FF2B5EF4-FFF2-40B4-BE49-F238E27FC236}">
                <a16:creationId xmlns:a16="http://schemas.microsoft.com/office/drawing/2014/main" id="{6EB4DCA4-55FE-4B88-E6B5-4C720AEA7740}"/>
              </a:ext>
            </a:extLst>
          </p:cNvPr>
          <p:cNvSpPr/>
          <p:nvPr/>
        </p:nvSpPr>
        <p:spPr>
          <a:xfrm>
            <a:off x="1477108" y="2400299"/>
            <a:ext cx="79331" cy="1354015"/>
          </a:xfrm>
          <a:prstGeom prst="leftBracket">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8" name="Parenthèse ouvrante 7">
            <a:extLst>
              <a:ext uri="{FF2B5EF4-FFF2-40B4-BE49-F238E27FC236}">
                <a16:creationId xmlns:a16="http://schemas.microsoft.com/office/drawing/2014/main" id="{5E1F6D83-0DD1-6333-30DE-98F745152D6F}"/>
              </a:ext>
            </a:extLst>
          </p:cNvPr>
          <p:cNvSpPr/>
          <p:nvPr/>
        </p:nvSpPr>
        <p:spPr>
          <a:xfrm>
            <a:off x="1477108" y="3815861"/>
            <a:ext cx="79331" cy="1354015"/>
          </a:xfrm>
          <a:prstGeom prst="leftBracket">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9" name="ZoneTexte 8">
            <a:extLst>
              <a:ext uri="{FF2B5EF4-FFF2-40B4-BE49-F238E27FC236}">
                <a16:creationId xmlns:a16="http://schemas.microsoft.com/office/drawing/2014/main" id="{A67CD7A3-0B5D-7713-0CE8-2E4B27BD836D}"/>
              </a:ext>
            </a:extLst>
          </p:cNvPr>
          <p:cNvSpPr txBox="1"/>
          <p:nvPr/>
        </p:nvSpPr>
        <p:spPr>
          <a:xfrm>
            <a:off x="187306" y="1907860"/>
            <a:ext cx="1341842" cy="307777"/>
          </a:xfrm>
          <a:prstGeom prst="rect">
            <a:avLst/>
          </a:prstGeom>
          <a:noFill/>
        </p:spPr>
        <p:txBody>
          <a:bodyPr wrap="none" rtlCol="0">
            <a:spAutoFit/>
          </a:bodyPr>
          <a:lstStyle/>
          <a:p>
            <a:r>
              <a:rPr lang="fr-FR" sz="1400" b="1" dirty="0"/>
              <a:t>CDS annotation</a:t>
            </a:r>
          </a:p>
        </p:txBody>
      </p:sp>
      <p:sp>
        <p:nvSpPr>
          <p:cNvPr id="10" name="ZoneTexte 9">
            <a:extLst>
              <a:ext uri="{FF2B5EF4-FFF2-40B4-BE49-F238E27FC236}">
                <a16:creationId xmlns:a16="http://schemas.microsoft.com/office/drawing/2014/main" id="{8C89F951-C04B-BB68-261B-9A7556129494}"/>
              </a:ext>
            </a:extLst>
          </p:cNvPr>
          <p:cNvSpPr txBox="1"/>
          <p:nvPr/>
        </p:nvSpPr>
        <p:spPr>
          <a:xfrm>
            <a:off x="199681" y="2888250"/>
            <a:ext cx="1095556" cy="523220"/>
          </a:xfrm>
          <a:prstGeom prst="rect">
            <a:avLst/>
          </a:prstGeom>
          <a:noFill/>
        </p:spPr>
        <p:txBody>
          <a:bodyPr wrap="none" rtlCol="0">
            <a:spAutoFit/>
          </a:bodyPr>
          <a:lstStyle/>
          <a:p>
            <a:r>
              <a:rPr lang="fr-FR" sz="1400" b="1" dirty="0"/>
              <a:t>SCV </a:t>
            </a:r>
            <a:r>
              <a:rPr lang="fr-FR" sz="1400" b="1" dirty="0" err="1"/>
              <a:t>method</a:t>
            </a:r>
            <a:endParaRPr lang="fr-FR" sz="1400" b="1" dirty="0"/>
          </a:p>
          <a:p>
            <a:r>
              <a:rPr lang="fr-FR" sz="1400" b="1" dirty="0"/>
              <a:t> annotation</a:t>
            </a:r>
          </a:p>
        </p:txBody>
      </p:sp>
      <p:sp>
        <p:nvSpPr>
          <p:cNvPr id="11" name="ZoneTexte 10">
            <a:extLst>
              <a:ext uri="{FF2B5EF4-FFF2-40B4-BE49-F238E27FC236}">
                <a16:creationId xmlns:a16="http://schemas.microsoft.com/office/drawing/2014/main" id="{3D1B4C59-A516-B81B-52CD-DA9464DFDF07}"/>
              </a:ext>
            </a:extLst>
          </p:cNvPr>
          <p:cNvSpPr txBox="1"/>
          <p:nvPr/>
        </p:nvSpPr>
        <p:spPr>
          <a:xfrm>
            <a:off x="193911" y="4333629"/>
            <a:ext cx="1328633" cy="523220"/>
          </a:xfrm>
          <a:prstGeom prst="rect">
            <a:avLst/>
          </a:prstGeom>
          <a:noFill/>
        </p:spPr>
        <p:txBody>
          <a:bodyPr wrap="none" rtlCol="0">
            <a:spAutoFit/>
          </a:bodyPr>
          <a:lstStyle/>
          <a:p>
            <a:r>
              <a:rPr lang="fr-FR" sz="1400" b="1" dirty="0" err="1"/>
              <a:t>Stringtie</a:t>
            </a:r>
            <a:r>
              <a:rPr lang="fr-FR" sz="1400" b="1" dirty="0"/>
              <a:t> merge</a:t>
            </a:r>
          </a:p>
          <a:p>
            <a:r>
              <a:rPr lang="fr-FR" sz="1400" b="1" dirty="0" err="1"/>
              <a:t>transcripts</a:t>
            </a:r>
            <a:endParaRPr lang="fr-FR" sz="1400" b="1" dirty="0"/>
          </a:p>
        </p:txBody>
      </p:sp>
      <p:sp>
        <p:nvSpPr>
          <p:cNvPr id="2" name="Rectangle 1"/>
          <p:cNvSpPr/>
          <p:nvPr/>
        </p:nvSpPr>
        <p:spPr>
          <a:xfrm>
            <a:off x="187306" y="5529462"/>
            <a:ext cx="8246076" cy="1060611"/>
          </a:xfrm>
          <a:prstGeom prst="rect">
            <a:avLst/>
          </a:prstGeom>
        </p:spPr>
        <p:txBody>
          <a:bodyPr wrap="square">
            <a:spAutoFit/>
          </a:bodyPr>
          <a:lstStyle/>
          <a:p>
            <a:pPr algn="just">
              <a:lnSpc>
                <a:spcPct val="200000"/>
              </a:lnSpc>
              <a:spcAft>
                <a:spcPts val="800"/>
              </a:spcAft>
            </a:pPr>
            <a:r>
              <a:rPr lang="en-US" sz="1100" b="1" dirty="0">
                <a:latin typeface="Calibri" panose="020F0502020204030204" pitchFamily="34" charset="0"/>
                <a:ea typeface="Calibri" panose="020F0502020204030204" pitchFamily="34" charset="0"/>
                <a:cs typeface="Calibri" panose="020F0502020204030204" pitchFamily="34" charset="0"/>
              </a:rPr>
              <a:t>Fig S1: Comparison of the SCV method annotation and StringTie merge results. </a:t>
            </a:r>
            <a:r>
              <a:rPr lang="en-US" sz="1100" dirty="0">
                <a:latin typeface="Calibri" panose="020F0502020204030204" pitchFamily="34" charset="0"/>
                <a:ea typeface="Calibri" panose="020F0502020204030204" pitchFamily="34" charset="0"/>
                <a:cs typeface="Calibri" panose="020F0502020204030204" pitchFamily="34" charset="0"/>
              </a:rPr>
              <a:t>The different annotation files have been visualized with IGV. This screenshot is representative of the rest of the genome. The small horizontal black lines show the positions of the TSS and TES for the SCV method annotation.</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52688199"/>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3</Words>
  <Application>Microsoft Office PowerPoint</Application>
  <PresentationFormat>Grand écran</PresentationFormat>
  <Paragraphs>6</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Times New Roman</vt:lpstr>
      <vt:lpstr>Thème Office</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Pierre GROGNET</dc:creator>
  <cp:lastModifiedBy>Pierre GROGNET</cp:lastModifiedBy>
  <cp:revision>3</cp:revision>
  <dcterms:created xsi:type="dcterms:W3CDTF">2022-07-21T15:05:59Z</dcterms:created>
  <dcterms:modified xsi:type="dcterms:W3CDTF">2022-12-01T06:43:35Z</dcterms:modified>
</cp:coreProperties>
</file>